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4.jpeg" ContentType="image/jpeg"/>
  <Override PartName="/ppt/media/image1.wmf" ContentType="image/x-wmf"/>
  <Override PartName="/ppt/media/image2.wmf" ContentType="image/x-wmf"/>
  <Override PartName="/ppt/media/image3.wmf" ContentType="image/x-wmf"/>
  <Override PartName="/ppt/media/image13.jpeg" ContentType="image/jpeg"/>
  <Override PartName="/ppt/media/image4.jpeg" ContentType="image/jpeg"/>
  <Override PartName="/ppt/media/image10.wmf" ContentType="image/x-wmf"/>
  <Override PartName="/ppt/media/image5.wmf" ContentType="image/x-wmf"/>
  <Override PartName="/ppt/media/image6.jpeg" ContentType="image/jpeg"/>
  <Override PartName="/ppt/media/image7.wmf" ContentType="image/x-wmf"/>
  <Override PartName="/ppt/media/image11.jpeg" ContentType="image/jpeg"/>
  <Override PartName="/ppt/media/image12.wmf" ContentType="image/x-wmf"/>
  <Override PartName="/ppt/media/image8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356937-0871-44B7-A711-F7C6380797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10B837-2B8B-4962-8737-4ADF34FC9B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DFB10C-AC48-4EB2-8D47-5292B072CE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2ABDCE-0E77-4953-ACF7-5667B9F5F3C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46041A-472B-4A43-83E4-B499A077C0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544E5F-9C41-474A-A0F7-0FA2A56DA6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8C682-9379-4000-A10E-01FA906D7E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E94A3-BEC1-40F1-81F2-2ABAD1D0CA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4E892-6769-4AE6-8483-CD986BBAC7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CB35EB-7622-4F6A-A470-8FD5B89AB9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65378D-99D0-4A5B-916B-05DAFF1979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6B4B2-A66A-4018-AAC5-7126D23BA0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00EBFE0-19B8-4DA1-83E2-DE989656FDFE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2.wmf"/><Relationship Id="rId3" Type="http://schemas.openxmlformats.org/officeDocument/2006/relationships/image" Target="../media/image2.wmf"/><Relationship Id="rId4" Type="http://schemas.openxmlformats.org/officeDocument/2006/relationships/slideLayout" Target="../slideLayouts/slideLayout2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image" Target="../media/image12.wmf"/><Relationship Id="rId3" Type="http://schemas.openxmlformats.org/officeDocument/2006/relationships/image" Target="../media/image14.jpeg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image" Target="../media/image5.wmf"/><Relationship Id="rId3" Type="http://schemas.openxmlformats.org/officeDocument/2006/relationships/image" Target="../media/image4.jpeg"/><Relationship Id="rId4" Type="http://schemas.openxmlformats.org/officeDocument/2006/relationships/image" Target="../media/image5.wmf"/><Relationship Id="rId5" Type="http://schemas.openxmlformats.org/officeDocument/2006/relationships/image" Target="../media/image2.wmf"/><Relationship Id="rId6" Type="http://schemas.openxmlformats.org/officeDocument/2006/relationships/slideLayout" Target="../slideLayouts/slideLayout2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7.wmf"/><Relationship Id="rId3" Type="http://schemas.openxmlformats.org/officeDocument/2006/relationships/image" Target="../media/image2.wmf"/><Relationship Id="rId4" Type="http://schemas.openxmlformats.org/officeDocument/2006/relationships/slideLayout" Target="../slideLayouts/slideLayout2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2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image" Target="../media/image10.wmf"/><Relationship Id="rId3" Type="http://schemas.openxmlformats.org/officeDocument/2006/relationships/image" Target="../media/image2.wmf"/><Relationship Id="rId4" Type="http://schemas.openxmlformats.org/officeDocument/2006/relationships/slideLayout" Target="../slideLayouts/slideLayout2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image" Target="../media/image12.wmf"/><Relationship Id="rId3" Type="http://schemas.openxmlformats.org/officeDocument/2006/relationships/image" Target="../media/image11.jpeg"/><Relationship Id="rId4" Type="http://schemas.openxmlformats.org/officeDocument/2006/relationships/image" Target="../media/image12.wmf"/><Relationship Id="rId5" Type="http://schemas.openxmlformats.org/officeDocument/2006/relationships/image" Target="../media/image2.wmf"/><Relationship Id="rId6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705400" y="800280"/>
            <a:ext cx="38916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Supplemental Figur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55640" y="2699640"/>
            <a:ext cx="7775640" cy="15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Supplemental Figure 1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Significant disease biological events that are common and specific to different subtypes of clinically NFPAs.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The blue bar means NF-NFPA. The light blue bar means LH-NFPA. The green bar means FSH-NFPA. The dark bar means LH/FSH-NFP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5" name=""/>
          <p:cNvGrpSpPr/>
          <p:nvPr/>
        </p:nvGrpSpPr>
        <p:grpSpPr>
          <a:xfrm>
            <a:off x="914400" y="-18720"/>
            <a:ext cx="7924320" cy="6495840"/>
            <a:chOff x="914400" y="-18720"/>
            <a:chExt cx="7924320" cy="6495840"/>
          </a:xfrm>
        </p:grpSpPr>
        <p:sp>
          <p:nvSpPr>
            <p:cNvPr id="156" name=""/>
            <p:cNvSpPr/>
            <p:nvPr/>
          </p:nvSpPr>
          <p:spPr>
            <a:xfrm>
              <a:off x="914400" y="380880"/>
              <a:ext cx="2819520" cy="5759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rdiac infra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rdiac fibro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rdiac necrosis/cell deat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Liver hyperplasia/hyperprolifer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rdiac inflamm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Renal necrosis/cell deat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Increased levels of hematocri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Increased levels of red blood cell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rdiac arteriopath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Glomerular injur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Liver cirrho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7" name=""/>
            <p:cNvGrpSpPr/>
            <p:nvPr/>
          </p:nvGrpSpPr>
          <p:grpSpPr>
            <a:xfrm>
              <a:off x="3505320" y="0"/>
              <a:ext cx="5333400" cy="6248160"/>
              <a:chOff x="3505320" y="0"/>
              <a:chExt cx="5333400" cy="6248160"/>
            </a:xfrm>
          </p:grpSpPr>
          <p:grpSp>
            <p:nvGrpSpPr>
              <p:cNvPr id="158" name=""/>
              <p:cNvGrpSpPr/>
              <p:nvPr/>
            </p:nvGrpSpPr>
            <p:grpSpPr>
              <a:xfrm>
                <a:off x="3505320" y="0"/>
                <a:ext cx="5333400" cy="6248160"/>
                <a:chOff x="3505320" y="0"/>
                <a:chExt cx="5333400" cy="6248160"/>
              </a:xfrm>
            </p:grpSpPr>
            <p:pic>
              <p:nvPicPr>
                <p:cNvPr id="159" name="" descr=""/>
                <p:cNvPicPr/>
                <p:nvPr/>
              </p:nvPicPr>
              <p:blipFill>
                <a:blip r:embed="rId1"/>
                <a:srcRect l="26201" t="5992" r="891" b="3355"/>
                <a:stretch/>
              </p:blipFill>
              <p:spPr>
                <a:xfrm>
                  <a:off x="3765600" y="419760"/>
                  <a:ext cx="5073120" cy="5828400"/>
                </a:xfrm>
                <a:prstGeom prst="rect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160" name="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3505320" y="0"/>
                  <a:ext cx="5177880" cy="4428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161" name=""/>
              <p:cNvSpPr/>
              <p:nvPr/>
            </p:nvSpPr>
            <p:spPr>
              <a:xfrm>
                <a:off x="3765240" y="943560"/>
                <a:ext cx="5063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3765240" y="1468440"/>
                <a:ext cx="5063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3765240" y="1992600"/>
                <a:ext cx="5063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3765240" y="2517480"/>
                <a:ext cx="5063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3765240" y="3094560"/>
                <a:ext cx="5063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3765240" y="3618360"/>
                <a:ext cx="5063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3765240" y="4143600"/>
                <a:ext cx="5063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3765240" y="4668480"/>
                <a:ext cx="5063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3765240" y="5192640"/>
                <a:ext cx="5063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3765240" y="5717520"/>
                <a:ext cx="5063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1" name=""/>
            <p:cNvSpPr/>
            <p:nvPr/>
          </p:nvSpPr>
          <p:spPr>
            <a:xfrm flipV="1">
              <a:off x="5943600" y="380520"/>
              <a:ext cx="0" cy="5867640"/>
            </a:xfrm>
            <a:prstGeom prst="line">
              <a:avLst/>
            </a:prstGeom>
            <a:ln w="12600">
              <a:solidFill>
                <a:srgbClr val="ff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 rot="16200000">
              <a:off x="5728320" y="164880"/>
              <a:ext cx="552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ff6600"/>
                  </a:solidFill>
                  <a:latin typeface="Arial"/>
                </a:rPr>
                <a:t>Threshol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73" name="" descr=""/>
            <p:cNvPicPr/>
            <p:nvPr/>
          </p:nvPicPr>
          <p:blipFill>
            <a:blip r:embed="rId3"/>
            <a:stretch/>
          </p:blipFill>
          <p:spPr>
            <a:xfrm>
              <a:off x="3733920" y="6256440"/>
              <a:ext cx="2438280" cy="220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74" name=""/>
          <p:cNvSpPr/>
          <p:nvPr/>
        </p:nvSpPr>
        <p:spPr>
          <a:xfrm>
            <a:off x="7020000" y="6583320"/>
            <a:ext cx="197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2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5" name=""/>
          <p:cNvGrpSpPr/>
          <p:nvPr/>
        </p:nvGrpSpPr>
        <p:grpSpPr>
          <a:xfrm>
            <a:off x="1371600" y="-1080"/>
            <a:ext cx="7391520" cy="6554160"/>
            <a:chOff x="1371600" y="-1080"/>
            <a:chExt cx="7391520" cy="6554160"/>
          </a:xfrm>
        </p:grpSpPr>
        <p:sp>
          <p:nvSpPr>
            <p:cNvPr id="176" name=""/>
            <p:cNvSpPr/>
            <p:nvPr/>
          </p:nvSpPr>
          <p:spPr>
            <a:xfrm>
              <a:off x="1371600" y="457200"/>
              <a:ext cx="2438280" cy="5759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Heart failu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Liver necrosis/cell deat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Increased levels of creatinin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rdiac outpu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Renal prolifer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Renal dama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Renal tubule injur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Liver cholesta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Liver fibro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rdiac hypertroph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Liver dama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7" name=""/>
            <p:cNvGrpSpPr/>
            <p:nvPr/>
          </p:nvGrpSpPr>
          <p:grpSpPr>
            <a:xfrm>
              <a:off x="3733920" y="76320"/>
              <a:ext cx="5029200" cy="6247800"/>
              <a:chOff x="3733920" y="76320"/>
              <a:chExt cx="5029200" cy="6247800"/>
            </a:xfrm>
          </p:grpSpPr>
          <p:pic>
            <p:nvPicPr>
              <p:cNvPr id="178" name="" descr=""/>
              <p:cNvPicPr/>
              <p:nvPr/>
            </p:nvPicPr>
            <p:blipFill>
              <a:blip r:embed="rId1"/>
              <a:srcRect l="25674" t="6993" r="3645" b="3091"/>
              <a:stretch/>
            </p:blipFill>
            <p:spPr>
              <a:xfrm>
                <a:off x="3813120" y="474120"/>
                <a:ext cx="4909320" cy="585000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grpSp>
            <p:nvGrpSpPr>
              <p:cNvPr id="179" name=""/>
              <p:cNvGrpSpPr/>
              <p:nvPr/>
            </p:nvGrpSpPr>
            <p:grpSpPr>
              <a:xfrm>
                <a:off x="3733920" y="76320"/>
                <a:ext cx="5029200" cy="6247800"/>
                <a:chOff x="3733920" y="76320"/>
                <a:chExt cx="5029200" cy="6247800"/>
              </a:xfrm>
            </p:grpSpPr>
            <p:pic>
              <p:nvPicPr>
                <p:cNvPr id="180" name="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3733920" y="76320"/>
                  <a:ext cx="5029200" cy="421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81" name="" descr=""/>
                <p:cNvPicPr/>
                <p:nvPr/>
              </p:nvPicPr>
              <p:blipFill>
                <a:blip r:embed="rId3"/>
                <a:srcRect l="25674" t="6993" r="3645" b="3091"/>
                <a:stretch/>
              </p:blipFill>
              <p:spPr>
                <a:xfrm>
                  <a:off x="3813120" y="474120"/>
                  <a:ext cx="4909320" cy="5850000"/>
                </a:xfrm>
                <a:prstGeom prst="rect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</p:pic>
          </p:grpSp>
          <p:sp>
            <p:nvSpPr>
              <p:cNvPr id="182" name=""/>
              <p:cNvSpPr/>
              <p:nvPr/>
            </p:nvSpPr>
            <p:spPr>
              <a:xfrm>
                <a:off x="3813120" y="948240"/>
                <a:ext cx="492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3813120" y="1498320"/>
                <a:ext cx="492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3813120" y="2023920"/>
                <a:ext cx="492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3813120" y="2574360"/>
                <a:ext cx="492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3813120" y="3098880"/>
                <a:ext cx="492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3813120" y="3648960"/>
                <a:ext cx="492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3813120" y="4173480"/>
                <a:ext cx="492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3813120" y="4723920"/>
                <a:ext cx="492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3813120" y="5248440"/>
                <a:ext cx="492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3813120" y="5798520"/>
                <a:ext cx="492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2" name=""/>
            <p:cNvSpPr/>
            <p:nvPr/>
          </p:nvSpPr>
          <p:spPr>
            <a:xfrm flipV="1">
              <a:off x="6019920" y="457200"/>
              <a:ext cx="0" cy="5867280"/>
            </a:xfrm>
            <a:prstGeom prst="line">
              <a:avLst/>
            </a:prstGeom>
            <a:ln w="12600">
              <a:solidFill>
                <a:srgbClr val="ff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 rot="16200000">
              <a:off x="5760000" y="182520"/>
              <a:ext cx="552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ff6600"/>
                  </a:solidFill>
                  <a:latin typeface="Arial"/>
                </a:rPr>
                <a:t>Threshol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94" name="" descr=""/>
            <p:cNvPicPr/>
            <p:nvPr/>
          </p:nvPicPr>
          <p:blipFill>
            <a:blip r:embed="rId4"/>
            <a:stretch/>
          </p:blipFill>
          <p:spPr>
            <a:xfrm>
              <a:off x="3809880" y="6332400"/>
              <a:ext cx="2438640" cy="220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95" name=""/>
          <p:cNvSpPr/>
          <p:nvPr/>
        </p:nvSpPr>
        <p:spPr>
          <a:xfrm>
            <a:off x="7020000" y="6583320"/>
            <a:ext cx="197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2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"/>
          <p:cNvSpPr/>
          <p:nvPr/>
        </p:nvSpPr>
        <p:spPr>
          <a:xfrm>
            <a:off x="7020000" y="6583320"/>
            <a:ext cx="197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1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"/>
          <p:cNvGrpSpPr/>
          <p:nvPr/>
        </p:nvGrpSpPr>
        <p:grpSpPr>
          <a:xfrm>
            <a:off x="434880" y="-101160"/>
            <a:ext cx="8458200" cy="6662160"/>
            <a:chOff x="434880" y="-101160"/>
            <a:chExt cx="8458200" cy="6662160"/>
          </a:xfrm>
        </p:grpSpPr>
        <p:sp>
          <p:nvSpPr>
            <p:cNvPr id="45" name=""/>
            <p:cNvSpPr/>
            <p:nvPr/>
          </p:nvSpPr>
          <p:spPr>
            <a:xfrm>
              <a:off x="434880" y="457200"/>
              <a:ext cx="3886200" cy="5812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Nervous system development and fun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Tissue morpholog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rdiovascular system development and fun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ell-to-cell signaling and intera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Hematological system development and fun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Immune cell traffickin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Inflammatory respon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ell death and surviva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Organismal developmen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Organismal injury and abnormaliti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ellular movemen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nc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Dermatological diseases and condition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ellular function and maintenanc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6" name="" descr=""/>
            <p:cNvPicPr/>
            <p:nvPr/>
          </p:nvPicPr>
          <p:blipFill>
            <a:blip r:embed="rId1"/>
            <a:stretch/>
          </p:blipFill>
          <p:spPr>
            <a:xfrm>
              <a:off x="4245120" y="0"/>
              <a:ext cx="4647960" cy="6324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"/>
            <p:cNvSpPr/>
            <p:nvPr/>
          </p:nvSpPr>
          <p:spPr>
            <a:xfrm>
              <a:off x="5126040" y="368280"/>
              <a:ext cx="0" cy="5943600"/>
            </a:xfrm>
            <a:prstGeom prst="line">
              <a:avLst/>
            </a:prstGeom>
            <a:ln w="12600">
              <a:solidFill>
                <a:srgbClr val="ff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rot="16200000">
              <a:off x="4856760" y="82440"/>
              <a:ext cx="552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ff6600"/>
                  </a:solidFill>
                  <a:latin typeface="Arial"/>
                </a:rPr>
                <a:t>Threshol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9" name="" descr=""/>
            <p:cNvPicPr/>
            <p:nvPr/>
          </p:nvPicPr>
          <p:blipFill>
            <a:blip r:embed="rId2"/>
            <a:stretch/>
          </p:blipFill>
          <p:spPr>
            <a:xfrm>
              <a:off x="4319640" y="6340320"/>
              <a:ext cx="2438280" cy="2206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"/>
          <p:cNvGrpSpPr/>
          <p:nvPr/>
        </p:nvGrpSpPr>
        <p:grpSpPr>
          <a:xfrm>
            <a:off x="228600" y="-18720"/>
            <a:ext cx="8686800" cy="6563880"/>
            <a:chOff x="228600" y="-18720"/>
            <a:chExt cx="8686800" cy="6563880"/>
          </a:xfrm>
        </p:grpSpPr>
        <p:sp>
          <p:nvSpPr>
            <p:cNvPr id="51" name=""/>
            <p:cNvSpPr/>
            <p:nvPr/>
          </p:nvSpPr>
          <p:spPr>
            <a:xfrm>
              <a:off x="228600" y="380880"/>
              <a:ext cx="3733920" cy="5812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ellular growth and pfolifer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Tissue developmen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ell morpholog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Endocrine system development and fun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Organ morpholog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Tumor morpholog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Gene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Hereditary disord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Protein synthe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rdiovascular dise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Neurological dise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Hematological dise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Nutritional dise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Lipid 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" descr=""/>
            <p:cNvPicPr/>
            <p:nvPr/>
          </p:nvPicPr>
          <p:blipFill>
            <a:blip r:embed="rId1"/>
            <a:stretch/>
          </p:blipFill>
          <p:spPr>
            <a:xfrm>
              <a:off x="3886200" y="0"/>
              <a:ext cx="5029200" cy="6324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"/>
            <p:cNvSpPr/>
            <p:nvPr/>
          </p:nvSpPr>
          <p:spPr>
            <a:xfrm flipV="1">
              <a:off x="4876920" y="457200"/>
              <a:ext cx="0" cy="5867280"/>
            </a:xfrm>
            <a:prstGeom prst="line">
              <a:avLst/>
            </a:prstGeom>
            <a:ln w="12600">
              <a:solidFill>
                <a:srgbClr val="ff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rot="16200000">
              <a:off x="4585320" y="164880"/>
              <a:ext cx="552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ff6600"/>
                  </a:solidFill>
                  <a:latin typeface="Arial"/>
                </a:rPr>
                <a:t>Threshol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5" name="" descr=""/>
            <p:cNvPicPr/>
            <p:nvPr/>
          </p:nvPicPr>
          <p:blipFill>
            <a:blip r:embed="rId2"/>
            <a:stretch/>
          </p:blipFill>
          <p:spPr>
            <a:xfrm>
              <a:off x="3962520" y="6324480"/>
              <a:ext cx="2438280" cy="220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6" name=""/>
          <p:cNvSpPr/>
          <p:nvPr/>
        </p:nvSpPr>
        <p:spPr>
          <a:xfrm>
            <a:off x="7020000" y="6583320"/>
            <a:ext cx="197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1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"/>
          <p:cNvGrpSpPr/>
          <p:nvPr/>
        </p:nvGrpSpPr>
        <p:grpSpPr>
          <a:xfrm>
            <a:off x="533520" y="-64440"/>
            <a:ext cx="8161200" cy="6625440"/>
            <a:chOff x="533520" y="-64440"/>
            <a:chExt cx="8161200" cy="6625440"/>
          </a:xfrm>
        </p:grpSpPr>
        <p:sp>
          <p:nvSpPr>
            <p:cNvPr id="58" name=""/>
            <p:cNvSpPr/>
            <p:nvPr/>
          </p:nvSpPr>
          <p:spPr>
            <a:xfrm>
              <a:off x="533520" y="422280"/>
              <a:ext cx="3657600" cy="5812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Molecular transpor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Small molecular biochemistr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ellular developmen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Hematopoie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ellular assembly and organiz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ell cyc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Reproductive system dise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rbohydrate 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Energy produ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Skeletal and muscular disorder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Psychological disorder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ell-mediated immune respon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Lymphoid tissue structure and developmen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ell signalin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9" name=""/>
            <p:cNvGrpSpPr/>
            <p:nvPr/>
          </p:nvGrpSpPr>
          <p:grpSpPr>
            <a:xfrm>
              <a:off x="4114800" y="76320"/>
              <a:ext cx="4579920" cy="6247440"/>
              <a:chOff x="4114800" y="76320"/>
              <a:chExt cx="4579920" cy="6247440"/>
            </a:xfrm>
          </p:grpSpPr>
          <p:pic>
            <p:nvPicPr>
              <p:cNvPr id="60" name="" descr=""/>
              <p:cNvPicPr/>
              <p:nvPr/>
            </p:nvPicPr>
            <p:blipFill>
              <a:blip r:embed="rId1"/>
              <a:srcRect l="39159" t="5442" r="1458" b="2359"/>
              <a:stretch/>
            </p:blipFill>
            <p:spPr>
              <a:xfrm>
                <a:off x="4215600" y="390960"/>
                <a:ext cx="4443480" cy="593244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pic>
            <p:nvPicPr>
              <p:cNvPr id="61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4114800" y="76320"/>
                <a:ext cx="4579920" cy="3157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62" name=""/>
              <p:cNvGrpSpPr/>
              <p:nvPr/>
            </p:nvGrpSpPr>
            <p:grpSpPr>
              <a:xfrm>
                <a:off x="4114800" y="77040"/>
                <a:ext cx="4579920" cy="6246720"/>
                <a:chOff x="4114800" y="77040"/>
                <a:chExt cx="4579920" cy="6246720"/>
              </a:xfrm>
            </p:grpSpPr>
            <p:pic>
              <p:nvPicPr>
                <p:cNvPr id="63" name="" descr=""/>
                <p:cNvPicPr/>
                <p:nvPr/>
              </p:nvPicPr>
              <p:blipFill>
                <a:blip r:embed="rId3"/>
                <a:srcRect l="39159" t="5442" r="1458" b="2359"/>
                <a:stretch/>
              </p:blipFill>
              <p:spPr>
                <a:xfrm>
                  <a:off x="4215600" y="392040"/>
                  <a:ext cx="4443480" cy="5931720"/>
                </a:xfrm>
                <a:prstGeom prst="rect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64" name="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4114800" y="77040"/>
                  <a:ext cx="4579920" cy="3157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65" name=""/>
              <p:cNvSpPr/>
              <p:nvPr/>
            </p:nvSpPr>
            <p:spPr>
              <a:xfrm>
                <a:off x="4215600" y="803520"/>
                <a:ext cx="44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4215600" y="1235880"/>
                <a:ext cx="44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4215600" y="1647360"/>
                <a:ext cx="44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4215600" y="2080440"/>
                <a:ext cx="44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4215600" y="2513880"/>
                <a:ext cx="44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4215600" y="2925360"/>
                <a:ext cx="44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4215600" y="3357720"/>
                <a:ext cx="44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4215600" y="3769200"/>
                <a:ext cx="44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4215600" y="4202640"/>
                <a:ext cx="44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4215600" y="4635000"/>
                <a:ext cx="44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4215600" y="5046120"/>
                <a:ext cx="44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4215600" y="5479560"/>
                <a:ext cx="44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4215600" y="5911920"/>
                <a:ext cx="44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8" name=""/>
            <p:cNvSpPr/>
            <p:nvPr/>
          </p:nvSpPr>
          <p:spPr>
            <a:xfrm>
              <a:off x="5003640" y="401760"/>
              <a:ext cx="0" cy="5943600"/>
            </a:xfrm>
            <a:prstGeom prst="line">
              <a:avLst/>
            </a:prstGeom>
            <a:ln w="12600">
              <a:solidFill>
                <a:srgbClr val="ff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rot="16200000">
              <a:off x="4744080" y="119160"/>
              <a:ext cx="552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ff6600"/>
                  </a:solidFill>
                  <a:latin typeface="Arial"/>
                </a:rPr>
                <a:t>Threshol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0" name="" descr=""/>
            <p:cNvPicPr/>
            <p:nvPr/>
          </p:nvPicPr>
          <p:blipFill>
            <a:blip r:embed="rId5"/>
            <a:stretch/>
          </p:blipFill>
          <p:spPr>
            <a:xfrm>
              <a:off x="4211640" y="6340320"/>
              <a:ext cx="2438280" cy="220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1" name=""/>
          <p:cNvSpPr/>
          <p:nvPr/>
        </p:nvSpPr>
        <p:spPr>
          <a:xfrm>
            <a:off x="7020000" y="6583320"/>
            <a:ext cx="197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1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"/>
          <p:cNvGrpSpPr/>
          <p:nvPr/>
        </p:nvGrpSpPr>
        <p:grpSpPr>
          <a:xfrm>
            <a:off x="380880" y="0"/>
            <a:ext cx="8458200" cy="6629400"/>
            <a:chOff x="380880" y="0"/>
            <a:chExt cx="8458200" cy="6629400"/>
          </a:xfrm>
        </p:grpSpPr>
        <p:sp>
          <p:nvSpPr>
            <p:cNvPr id="83" name=""/>
            <p:cNvSpPr/>
            <p:nvPr/>
          </p:nvSpPr>
          <p:spPr>
            <a:xfrm>
              <a:off x="380880" y="498600"/>
              <a:ext cx="3810240" cy="5812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Vitamin and mineral 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Embryonic developmen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Organ developmen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Inflammatory dise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Organismal surviva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Endocrine system disorder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Gastrointestinal dise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Metabolic dise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Infectious dise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DNA replication, recombination, and repai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Nucleic acid 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Reproductive system development and fun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Immunological dise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Skeletal muscular system development and functio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4" name=""/>
            <p:cNvGrpSpPr/>
            <p:nvPr/>
          </p:nvGrpSpPr>
          <p:grpSpPr>
            <a:xfrm>
              <a:off x="4114800" y="0"/>
              <a:ext cx="4724280" cy="6384600"/>
              <a:chOff x="4114800" y="0"/>
              <a:chExt cx="4724280" cy="6384600"/>
            </a:xfrm>
          </p:grpSpPr>
          <p:grpSp>
            <p:nvGrpSpPr>
              <p:cNvPr id="85" name=""/>
              <p:cNvGrpSpPr/>
              <p:nvPr/>
            </p:nvGrpSpPr>
            <p:grpSpPr>
              <a:xfrm>
                <a:off x="4114800" y="0"/>
                <a:ext cx="4724280" cy="6384600"/>
                <a:chOff x="4114800" y="0"/>
                <a:chExt cx="4724280" cy="6384600"/>
              </a:xfrm>
            </p:grpSpPr>
            <p:pic>
              <p:nvPicPr>
                <p:cNvPr id="86" name="" descr=""/>
                <p:cNvPicPr/>
                <p:nvPr/>
              </p:nvPicPr>
              <p:blipFill>
                <a:blip r:embed="rId1"/>
                <a:srcRect l="39281" t="5223" r="2389" b="2457"/>
                <a:stretch/>
              </p:blipFill>
              <p:spPr>
                <a:xfrm>
                  <a:off x="4236840" y="555120"/>
                  <a:ext cx="4505400" cy="5829480"/>
                </a:xfrm>
                <a:prstGeom prst="rect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87" name="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4114800" y="0"/>
                  <a:ext cx="4724280" cy="5533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88" name=""/>
              <p:cNvSpPr/>
              <p:nvPr/>
            </p:nvSpPr>
            <p:spPr>
              <a:xfrm>
                <a:off x="4236840" y="977040"/>
                <a:ext cx="450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4236840" y="1362240"/>
                <a:ext cx="450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4236840" y="1783080"/>
                <a:ext cx="450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4236840" y="2239200"/>
                <a:ext cx="450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4236840" y="2659680"/>
                <a:ext cx="450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4236840" y="3080520"/>
                <a:ext cx="450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4236840" y="3501000"/>
                <a:ext cx="450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4236840" y="3922920"/>
                <a:ext cx="450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4236840" y="4308120"/>
                <a:ext cx="450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4236840" y="4728600"/>
                <a:ext cx="450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4236840" y="5149440"/>
                <a:ext cx="450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4236840" y="5571720"/>
                <a:ext cx="450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4236840" y="5992200"/>
                <a:ext cx="450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1" name=""/>
            <p:cNvSpPr/>
            <p:nvPr/>
          </p:nvSpPr>
          <p:spPr>
            <a:xfrm flipV="1">
              <a:off x="5029200" y="533520"/>
              <a:ext cx="0" cy="5867280"/>
            </a:xfrm>
            <a:prstGeom prst="line">
              <a:avLst/>
            </a:prstGeom>
            <a:ln w="12600">
              <a:solidFill>
                <a:srgbClr val="ff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rot="16200000">
              <a:off x="4769280" y="241200"/>
              <a:ext cx="552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ff6600"/>
                  </a:solidFill>
                  <a:latin typeface="Arial"/>
                </a:rPr>
                <a:t>Threshol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3" name="" descr=""/>
            <p:cNvPicPr/>
            <p:nvPr/>
          </p:nvPicPr>
          <p:blipFill>
            <a:blip r:embed="rId3"/>
            <a:stretch/>
          </p:blipFill>
          <p:spPr>
            <a:xfrm>
              <a:off x="4191120" y="6408720"/>
              <a:ext cx="2438280" cy="220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04" name=""/>
          <p:cNvSpPr/>
          <p:nvPr/>
        </p:nvSpPr>
        <p:spPr>
          <a:xfrm>
            <a:off x="7020000" y="6583320"/>
            <a:ext cx="197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1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5" name=""/>
          <p:cNvGrpSpPr/>
          <p:nvPr/>
        </p:nvGrpSpPr>
        <p:grpSpPr>
          <a:xfrm>
            <a:off x="380880" y="-18720"/>
            <a:ext cx="8686800" cy="6640200"/>
            <a:chOff x="380880" y="-18720"/>
            <a:chExt cx="8686800" cy="6640200"/>
          </a:xfrm>
        </p:grpSpPr>
        <p:sp>
          <p:nvSpPr>
            <p:cNvPr id="106" name=""/>
            <p:cNvSpPr/>
            <p:nvPr/>
          </p:nvSpPr>
          <p:spPr>
            <a:xfrm>
              <a:off x="380880" y="345960"/>
              <a:ext cx="3962520" cy="5812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Digestive system development and fun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Amino acid 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ellular compromi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Developmental disord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Hepatic system dise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Renal and urological dise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onnective tissue development and fun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Drug 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Hair and skin development and fun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Post-translational modific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Behavio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Humoral immune respon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Organismal function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Renal and urological system development and functio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7" name="" descr=""/>
            <p:cNvPicPr/>
            <p:nvPr/>
          </p:nvPicPr>
          <p:blipFill>
            <a:blip r:embed="rId1"/>
            <a:stretch/>
          </p:blipFill>
          <p:spPr>
            <a:xfrm>
              <a:off x="4251240" y="0"/>
              <a:ext cx="4816440" cy="6400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8" name=""/>
            <p:cNvSpPr/>
            <p:nvPr/>
          </p:nvSpPr>
          <p:spPr>
            <a:xfrm flipV="1">
              <a:off x="5181480" y="304560"/>
              <a:ext cx="0" cy="6095880"/>
            </a:xfrm>
            <a:prstGeom prst="line">
              <a:avLst/>
            </a:prstGeom>
            <a:ln w="12600">
              <a:solidFill>
                <a:srgbClr val="ff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rot="16200000">
              <a:off x="4921920" y="164880"/>
              <a:ext cx="552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ff6600"/>
                  </a:solidFill>
                  <a:latin typeface="Arial"/>
                </a:rPr>
                <a:t>Threshol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0" name="" descr=""/>
            <p:cNvPicPr/>
            <p:nvPr/>
          </p:nvPicPr>
          <p:blipFill>
            <a:blip r:embed="rId2"/>
            <a:stretch/>
          </p:blipFill>
          <p:spPr>
            <a:xfrm>
              <a:off x="4343400" y="6400800"/>
              <a:ext cx="2438280" cy="220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11" name=""/>
          <p:cNvSpPr/>
          <p:nvPr/>
        </p:nvSpPr>
        <p:spPr>
          <a:xfrm>
            <a:off x="7020000" y="6583320"/>
            <a:ext cx="197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1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" name=""/>
          <p:cNvGrpSpPr/>
          <p:nvPr/>
        </p:nvGrpSpPr>
        <p:grpSpPr>
          <a:xfrm>
            <a:off x="609480" y="6840"/>
            <a:ext cx="7925040" cy="6343200"/>
            <a:chOff x="609480" y="6840"/>
            <a:chExt cx="7925040" cy="6343200"/>
          </a:xfrm>
        </p:grpSpPr>
        <p:sp>
          <p:nvSpPr>
            <p:cNvPr id="113" name=""/>
            <p:cNvSpPr/>
            <p:nvPr/>
          </p:nvSpPr>
          <p:spPr>
            <a:xfrm>
              <a:off x="609480" y="563400"/>
              <a:ext cx="3505320" cy="5301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onnective tissue disorder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Free radical scavengin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Hepatic system development and fun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Visual system development and fun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Protein degrad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Hypersensitivity respon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Respiratory dise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Protein folidin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RNA post-transcriptional modific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Protein traffickin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Respiratory system development and fun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Auditory disease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4" name=""/>
            <p:cNvGrpSpPr/>
            <p:nvPr/>
          </p:nvGrpSpPr>
          <p:grpSpPr>
            <a:xfrm>
              <a:off x="4114800" y="154080"/>
              <a:ext cx="4419720" cy="5941800"/>
              <a:chOff x="4114800" y="154080"/>
              <a:chExt cx="4419720" cy="5941800"/>
            </a:xfrm>
          </p:grpSpPr>
          <p:grpSp>
            <p:nvGrpSpPr>
              <p:cNvPr id="115" name=""/>
              <p:cNvGrpSpPr/>
              <p:nvPr/>
            </p:nvGrpSpPr>
            <p:grpSpPr>
              <a:xfrm>
                <a:off x="4114800" y="154080"/>
                <a:ext cx="4419720" cy="5941800"/>
                <a:chOff x="4114800" y="154080"/>
                <a:chExt cx="4419720" cy="5941800"/>
              </a:xfrm>
            </p:grpSpPr>
            <p:pic>
              <p:nvPicPr>
                <p:cNvPr id="116" name="" descr=""/>
                <p:cNvPicPr/>
                <p:nvPr/>
              </p:nvPicPr>
              <p:blipFill>
                <a:blip r:embed="rId1"/>
                <a:srcRect l="2666" t="3299" r="3111" b="3238"/>
                <a:stretch/>
              </p:blipFill>
              <p:spPr>
                <a:xfrm>
                  <a:off x="4179960" y="477360"/>
                  <a:ext cx="4281120" cy="5618520"/>
                </a:xfrm>
                <a:prstGeom prst="rect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117" name="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4114800" y="154080"/>
                  <a:ext cx="4419720" cy="3276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118" name=""/>
              <p:cNvSpPr/>
              <p:nvPr/>
            </p:nvSpPr>
            <p:spPr>
              <a:xfrm>
                <a:off x="4180320" y="869040"/>
                <a:ext cx="428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4180320" y="1346760"/>
                <a:ext cx="428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4180320" y="1843200"/>
                <a:ext cx="428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4180320" y="2320200"/>
                <a:ext cx="428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4180320" y="2777400"/>
                <a:ext cx="428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4180320" y="3293640"/>
                <a:ext cx="428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4180320" y="3730680"/>
                <a:ext cx="428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4180320" y="4208400"/>
                <a:ext cx="428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4180320" y="4685040"/>
                <a:ext cx="428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4180320" y="5141520"/>
                <a:ext cx="428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4180320" y="5599080"/>
                <a:ext cx="428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9" name=""/>
            <p:cNvSpPr/>
            <p:nvPr/>
          </p:nvSpPr>
          <p:spPr>
            <a:xfrm flipV="1">
              <a:off x="4932360" y="441000"/>
              <a:ext cx="0" cy="5638680"/>
            </a:xfrm>
            <a:prstGeom prst="line">
              <a:avLst/>
            </a:prstGeom>
            <a:ln w="12600">
              <a:solidFill>
                <a:srgbClr val="ff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 rot="16200000">
              <a:off x="4675680" y="190440"/>
              <a:ext cx="552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ff6600"/>
                  </a:solidFill>
                  <a:latin typeface="Arial"/>
                </a:rPr>
                <a:t>Threshol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1" name="" descr=""/>
            <p:cNvPicPr/>
            <p:nvPr/>
          </p:nvPicPr>
          <p:blipFill>
            <a:blip r:embed="rId3"/>
            <a:stretch/>
          </p:blipFill>
          <p:spPr>
            <a:xfrm>
              <a:off x="4140360" y="6129360"/>
              <a:ext cx="2438280" cy="220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32" name=""/>
          <p:cNvSpPr/>
          <p:nvPr/>
        </p:nvSpPr>
        <p:spPr>
          <a:xfrm>
            <a:off x="7020000" y="6583320"/>
            <a:ext cx="197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1F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"/>
          <p:cNvSpPr/>
          <p:nvPr/>
        </p:nvSpPr>
        <p:spPr>
          <a:xfrm>
            <a:off x="792000" y="1806120"/>
            <a:ext cx="7775640" cy="15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Supplemental Figure 2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Significant tox biological events that are common and specific to different subtypes of clinically NFPAs.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The blue bar means NF-NFPA. The light blue bar means LH-NFPA. The green bar means FSH-NFPA. The dark bar means LH/FSH-NFP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4" name=""/>
          <p:cNvGrpSpPr/>
          <p:nvPr/>
        </p:nvGrpSpPr>
        <p:grpSpPr>
          <a:xfrm>
            <a:off x="1143000" y="-75600"/>
            <a:ext cx="7542000" cy="6636600"/>
            <a:chOff x="1143000" y="-75600"/>
            <a:chExt cx="7542000" cy="6636600"/>
          </a:xfrm>
        </p:grpSpPr>
        <p:sp>
          <p:nvSpPr>
            <p:cNvPr id="135" name=""/>
            <p:cNvSpPr/>
            <p:nvPr/>
          </p:nvSpPr>
          <p:spPr>
            <a:xfrm>
              <a:off x="1143000" y="380880"/>
              <a:ext cx="2666880" cy="5758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rdiac arrhythmi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Liver hypertroph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Renal inflamm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Renal nephrit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rdiac pulmonary em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Cardiac steno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Increased levels of bilirub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Kidney failu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Increased levels of potassium,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Arial"/>
                </a:rPr>
                <a:t>Glutathione depletion inliv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6" name=""/>
            <p:cNvGrpSpPr/>
            <p:nvPr/>
          </p:nvGrpSpPr>
          <p:grpSpPr>
            <a:xfrm>
              <a:off x="3635280" y="0"/>
              <a:ext cx="5049720" cy="6324480"/>
              <a:chOff x="3635280" y="0"/>
              <a:chExt cx="5049720" cy="6324480"/>
            </a:xfrm>
          </p:grpSpPr>
          <p:pic>
            <p:nvPicPr>
              <p:cNvPr id="137" name="" descr=""/>
              <p:cNvPicPr/>
              <p:nvPr/>
            </p:nvPicPr>
            <p:blipFill>
              <a:blip r:embed="rId1"/>
              <a:srcRect l="25751" t="9298" r="3041" b="3481"/>
              <a:stretch/>
            </p:blipFill>
            <p:spPr>
              <a:xfrm>
                <a:off x="3844080" y="390240"/>
                <a:ext cx="4840920" cy="593424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pic>
            <p:nvPicPr>
              <p:cNvPr id="138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3635280" y="0"/>
                <a:ext cx="5047560" cy="40860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39" name=""/>
              <p:cNvGrpSpPr/>
              <p:nvPr/>
            </p:nvGrpSpPr>
            <p:grpSpPr>
              <a:xfrm>
                <a:off x="3635280" y="0"/>
                <a:ext cx="5049720" cy="6324480"/>
                <a:chOff x="3635280" y="0"/>
                <a:chExt cx="5049720" cy="6324480"/>
              </a:xfrm>
            </p:grpSpPr>
            <p:pic>
              <p:nvPicPr>
                <p:cNvPr id="140" name="" descr=""/>
                <p:cNvPicPr/>
                <p:nvPr/>
              </p:nvPicPr>
              <p:blipFill>
                <a:blip r:embed="rId3"/>
                <a:srcRect l="25751" t="9298" r="3041" b="3481"/>
                <a:stretch/>
              </p:blipFill>
              <p:spPr>
                <a:xfrm>
                  <a:off x="3844080" y="390240"/>
                  <a:ext cx="4840920" cy="5934240"/>
                </a:xfrm>
                <a:prstGeom prst="rect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141" name="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3635280" y="0"/>
                  <a:ext cx="5047560" cy="4086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142" name=""/>
              <p:cNvSpPr/>
              <p:nvPr/>
            </p:nvSpPr>
            <p:spPr>
              <a:xfrm>
                <a:off x="3844080" y="1000440"/>
                <a:ext cx="4838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3844080" y="1562040"/>
                <a:ext cx="4838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3844080" y="2122200"/>
                <a:ext cx="4838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3844080" y="2757240"/>
                <a:ext cx="4838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3844080" y="3318840"/>
                <a:ext cx="4838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3844080" y="3928680"/>
                <a:ext cx="4838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3844080" y="4514040"/>
                <a:ext cx="4838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3844080" y="5148720"/>
                <a:ext cx="4838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3844080" y="5733720"/>
                <a:ext cx="4838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1" name=""/>
            <p:cNvSpPr/>
            <p:nvPr/>
          </p:nvSpPr>
          <p:spPr>
            <a:xfrm>
              <a:off x="6019920" y="380880"/>
              <a:ext cx="0" cy="5943600"/>
            </a:xfrm>
            <a:prstGeom prst="line">
              <a:avLst/>
            </a:prstGeom>
            <a:ln w="12600">
              <a:solidFill>
                <a:srgbClr val="ff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rot="16200000">
              <a:off x="5752080" y="108000"/>
              <a:ext cx="552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ff6600"/>
                  </a:solidFill>
                  <a:latin typeface="Arial"/>
                </a:rPr>
                <a:t>Threshol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53" name="" descr=""/>
            <p:cNvPicPr/>
            <p:nvPr/>
          </p:nvPicPr>
          <p:blipFill>
            <a:blip r:embed="rId5"/>
            <a:stretch/>
          </p:blipFill>
          <p:spPr>
            <a:xfrm>
              <a:off x="3825720" y="6340320"/>
              <a:ext cx="2438640" cy="220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54" name=""/>
          <p:cNvSpPr/>
          <p:nvPr/>
        </p:nvSpPr>
        <p:spPr>
          <a:xfrm>
            <a:off x="7020000" y="6583320"/>
            <a:ext cx="197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2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28T04:31:42Z</dcterms:created>
  <dc:creator>Administrator</dc:creator>
  <dc:description/>
  <dc:language>en-US</dc:language>
  <cp:lastModifiedBy>MC SYSTEM</cp:lastModifiedBy>
  <dcterms:modified xsi:type="dcterms:W3CDTF">2014-09-06T10:10:27Z</dcterms:modified>
  <cp:revision>18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